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22860000" cy="51206400"/>
  <p:notesSz cx="6858000" cy="9144000"/>
  <p:defaultTextStyle>
    <a:defPPr>
      <a:defRPr lang="en-US"/>
    </a:defPPr>
    <a:lvl1pPr marL="0" algn="l" defTabSz="5535408" rtl="0" eaLnBrk="1" latinLnBrk="0" hangingPunct="1">
      <a:defRPr sz="10900" kern="1200">
        <a:solidFill>
          <a:schemeClr val="tx1"/>
        </a:solidFill>
        <a:latin typeface="+mn-lt"/>
        <a:ea typeface="+mn-ea"/>
        <a:cs typeface="+mn-cs"/>
      </a:defRPr>
    </a:lvl1pPr>
    <a:lvl2pPr marL="2767701" algn="l" defTabSz="5535408" rtl="0" eaLnBrk="1" latinLnBrk="0" hangingPunct="1">
      <a:defRPr sz="10900" kern="1200">
        <a:solidFill>
          <a:schemeClr val="tx1"/>
        </a:solidFill>
        <a:latin typeface="+mn-lt"/>
        <a:ea typeface="+mn-ea"/>
        <a:cs typeface="+mn-cs"/>
      </a:defRPr>
    </a:lvl2pPr>
    <a:lvl3pPr marL="5535408" algn="l" defTabSz="5535408" rtl="0" eaLnBrk="1" latinLnBrk="0" hangingPunct="1">
      <a:defRPr sz="10900" kern="1200">
        <a:solidFill>
          <a:schemeClr val="tx1"/>
        </a:solidFill>
        <a:latin typeface="+mn-lt"/>
        <a:ea typeface="+mn-ea"/>
        <a:cs typeface="+mn-cs"/>
      </a:defRPr>
    </a:lvl3pPr>
    <a:lvl4pPr marL="8303109" algn="l" defTabSz="5535408" rtl="0" eaLnBrk="1" latinLnBrk="0" hangingPunct="1">
      <a:defRPr sz="10900" kern="1200">
        <a:solidFill>
          <a:schemeClr val="tx1"/>
        </a:solidFill>
        <a:latin typeface="+mn-lt"/>
        <a:ea typeface="+mn-ea"/>
        <a:cs typeface="+mn-cs"/>
      </a:defRPr>
    </a:lvl4pPr>
    <a:lvl5pPr marL="11070816" algn="l" defTabSz="5535408" rtl="0" eaLnBrk="1" latinLnBrk="0" hangingPunct="1">
      <a:defRPr sz="10900" kern="1200">
        <a:solidFill>
          <a:schemeClr val="tx1"/>
        </a:solidFill>
        <a:latin typeface="+mn-lt"/>
        <a:ea typeface="+mn-ea"/>
        <a:cs typeface="+mn-cs"/>
      </a:defRPr>
    </a:lvl5pPr>
    <a:lvl6pPr marL="13838523" algn="l" defTabSz="5535408" rtl="0" eaLnBrk="1" latinLnBrk="0" hangingPunct="1">
      <a:defRPr sz="10900" kern="1200">
        <a:solidFill>
          <a:schemeClr val="tx1"/>
        </a:solidFill>
        <a:latin typeface="+mn-lt"/>
        <a:ea typeface="+mn-ea"/>
        <a:cs typeface="+mn-cs"/>
      </a:defRPr>
    </a:lvl6pPr>
    <a:lvl7pPr marL="16606224" algn="l" defTabSz="5535408" rtl="0" eaLnBrk="1" latinLnBrk="0" hangingPunct="1">
      <a:defRPr sz="10900" kern="1200">
        <a:solidFill>
          <a:schemeClr val="tx1"/>
        </a:solidFill>
        <a:latin typeface="+mn-lt"/>
        <a:ea typeface="+mn-ea"/>
        <a:cs typeface="+mn-cs"/>
      </a:defRPr>
    </a:lvl7pPr>
    <a:lvl8pPr marL="19373931" algn="l" defTabSz="5535408" rtl="0" eaLnBrk="1" latinLnBrk="0" hangingPunct="1">
      <a:defRPr sz="10900" kern="1200">
        <a:solidFill>
          <a:schemeClr val="tx1"/>
        </a:solidFill>
        <a:latin typeface="+mn-lt"/>
        <a:ea typeface="+mn-ea"/>
        <a:cs typeface="+mn-cs"/>
      </a:defRPr>
    </a:lvl8pPr>
    <a:lvl9pPr marL="22141632" algn="l" defTabSz="5535408" rtl="0" eaLnBrk="1" latinLnBrk="0" hangingPunct="1">
      <a:defRPr sz="109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30" d="100"/>
          <a:sy n="30" d="100"/>
        </p:scale>
        <p:origin x="-470" y="7584"/>
      </p:cViewPr>
      <p:guideLst>
        <p:guide orient="horz" pos="16128"/>
        <p:guide pos="720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714500" y="15907185"/>
            <a:ext cx="19431000" cy="10976187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3429000" y="29016960"/>
            <a:ext cx="16002000" cy="1308608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276770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553540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830310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107081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1383852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1660622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1937393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2214163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19D83F-DCB4-4FB4-9496-8CDF22EF0675}" type="datetimeFigureOut">
              <a:rPr lang="en-US" smtClean="0"/>
              <a:t>7/13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590B27-B76F-4BE1-B4F1-F0FA2F71961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4026355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19D83F-DCB4-4FB4-9496-8CDF22EF0675}" type="datetimeFigureOut">
              <a:rPr lang="en-US" smtClean="0"/>
              <a:t>7/13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590B27-B76F-4BE1-B4F1-F0FA2F71961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464822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92813188" y="13666909"/>
            <a:ext cx="28801220" cy="29128381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401599" y="13666909"/>
            <a:ext cx="86030593" cy="29128381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19D83F-DCB4-4FB4-9496-8CDF22EF0675}" type="datetimeFigureOut">
              <a:rPr lang="en-US" smtClean="0"/>
              <a:t>7/13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590B27-B76F-4BE1-B4F1-F0FA2F71961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0229101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19D83F-DCB4-4FB4-9496-8CDF22EF0675}" type="datetimeFigureOut">
              <a:rPr lang="en-US" smtClean="0"/>
              <a:t>7/13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590B27-B76F-4BE1-B4F1-F0FA2F71961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2501042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805783" y="32904865"/>
            <a:ext cx="19431000" cy="10170160"/>
          </a:xfrm>
        </p:spPr>
        <p:txBody>
          <a:bodyPr anchor="t"/>
          <a:lstStyle>
            <a:lvl1pPr algn="l">
              <a:defRPr sz="242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805783" y="21703470"/>
            <a:ext cx="19431000" cy="11201396"/>
          </a:xfrm>
        </p:spPr>
        <p:txBody>
          <a:bodyPr anchor="b"/>
          <a:lstStyle>
            <a:lvl1pPr marL="0" indent="0">
              <a:buNone/>
              <a:defRPr sz="12100">
                <a:solidFill>
                  <a:schemeClr val="tx1">
                    <a:tint val="75000"/>
                  </a:schemeClr>
                </a:solidFill>
              </a:defRPr>
            </a:lvl1pPr>
            <a:lvl2pPr marL="2767701" indent="0">
              <a:buNone/>
              <a:defRPr sz="10900">
                <a:solidFill>
                  <a:schemeClr val="tx1">
                    <a:tint val="75000"/>
                  </a:schemeClr>
                </a:solidFill>
              </a:defRPr>
            </a:lvl2pPr>
            <a:lvl3pPr marL="5535408" indent="0">
              <a:buNone/>
              <a:defRPr sz="9700">
                <a:solidFill>
                  <a:schemeClr val="tx1">
                    <a:tint val="75000"/>
                  </a:schemeClr>
                </a:solidFill>
              </a:defRPr>
            </a:lvl3pPr>
            <a:lvl4pPr marL="8303109" indent="0">
              <a:buNone/>
              <a:defRPr sz="8500">
                <a:solidFill>
                  <a:schemeClr val="tx1">
                    <a:tint val="75000"/>
                  </a:schemeClr>
                </a:solidFill>
              </a:defRPr>
            </a:lvl4pPr>
            <a:lvl5pPr marL="11070816" indent="0">
              <a:buNone/>
              <a:defRPr sz="8500">
                <a:solidFill>
                  <a:schemeClr val="tx1">
                    <a:tint val="75000"/>
                  </a:schemeClr>
                </a:solidFill>
              </a:defRPr>
            </a:lvl5pPr>
            <a:lvl6pPr marL="13838523" indent="0">
              <a:buNone/>
              <a:defRPr sz="8500">
                <a:solidFill>
                  <a:schemeClr val="tx1">
                    <a:tint val="75000"/>
                  </a:schemeClr>
                </a:solidFill>
              </a:defRPr>
            </a:lvl6pPr>
            <a:lvl7pPr marL="16606224" indent="0">
              <a:buNone/>
              <a:defRPr sz="8500">
                <a:solidFill>
                  <a:schemeClr val="tx1">
                    <a:tint val="75000"/>
                  </a:schemeClr>
                </a:solidFill>
              </a:defRPr>
            </a:lvl7pPr>
            <a:lvl8pPr marL="19373931" indent="0">
              <a:buNone/>
              <a:defRPr sz="8500">
                <a:solidFill>
                  <a:schemeClr val="tx1">
                    <a:tint val="75000"/>
                  </a:schemeClr>
                </a:solidFill>
              </a:defRPr>
            </a:lvl8pPr>
            <a:lvl9pPr marL="22141632" indent="0">
              <a:buNone/>
              <a:defRPr sz="85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19D83F-DCB4-4FB4-9496-8CDF22EF0675}" type="datetimeFigureOut">
              <a:rPr lang="en-US" smtClean="0"/>
              <a:t>7/13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590B27-B76F-4BE1-B4F1-F0FA2F71961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1984158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401596" y="79654404"/>
            <a:ext cx="57415905" cy="225296310"/>
          </a:xfrm>
        </p:spPr>
        <p:txBody>
          <a:bodyPr/>
          <a:lstStyle>
            <a:lvl1pPr>
              <a:defRPr sz="17000"/>
            </a:lvl1pPr>
            <a:lvl2pPr>
              <a:defRPr sz="14500"/>
            </a:lvl2pPr>
            <a:lvl3pPr>
              <a:defRPr sz="12100"/>
            </a:lvl3pPr>
            <a:lvl4pPr>
              <a:defRPr sz="10900"/>
            </a:lvl4pPr>
            <a:lvl5pPr>
              <a:defRPr sz="10900"/>
            </a:lvl5pPr>
            <a:lvl6pPr>
              <a:defRPr sz="10900"/>
            </a:lvl6pPr>
            <a:lvl7pPr>
              <a:defRPr sz="10900"/>
            </a:lvl7pPr>
            <a:lvl8pPr>
              <a:defRPr sz="10900"/>
            </a:lvl8pPr>
            <a:lvl9pPr>
              <a:defRPr sz="109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4198504" y="79654404"/>
            <a:ext cx="57415908" cy="225296310"/>
          </a:xfrm>
        </p:spPr>
        <p:txBody>
          <a:bodyPr/>
          <a:lstStyle>
            <a:lvl1pPr>
              <a:defRPr sz="17000"/>
            </a:lvl1pPr>
            <a:lvl2pPr>
              <a:defRPr sz="14500"/>
            </a:lvl2pPr>
            <a:lvl3pPr>
              <a:defRPr sz="12100"/>
            </a:lvl3pPr>
            <a:lvl4pPr>
              <a:defRPr sz="10900"/>
            </a:lvl4pPr>
            <a:lvl5pPr>
              <a:defRPr sz="10900"/>
            </a:lvl5pPr>
            <a:lvl6pPr>
              <a:defRPr sz="10900"/>
            </a:lvl6pPr>
            <a:lvl7pPr>
              <a:defRPr sz="10900"/>
            </a:lvl7pPr>
            <a:lvl8pPr>
              <a:defRPr sz="10900"/>
            </a:lvl8pPr>
            <a:lvl9pPr>
              <a:defRPr sz="109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19D83F-DCB4-4FB4-9496-8CDF22EF0675}" type="datetimeFigureOut">
              <a:rPr lang="en-US" smtClean="0"/>
              <a:t>7/13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590B27-B76F-4BE1-B4F1-F0FA2F71961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3848793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43000" y="2050630"/>
            <a:ext cx="20574000" cy="85344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143001" y="11462177"/>
            <a:ext cx="10100470" cy="4776890"/>
          </a:xfrm>
        </p:spPr>
        <p:txBody>
          <a:bodyPr anchor="b"/>
          <a:lstStyle>
            <a:lvl1pPr marL="0" indent="0">
              <a:buNone/>
              <a:defRPr sz="14500" b="1"/>
            </a:lvl1pPr>
            <a:lvl2pPr marL="2767701" indent="0">
              <a:buNone/>
              <a:defRPr sz="12100" b="1"/>
            </a:lvl2pPr>
            <a:lvl3pPr marL="5535408" indent="0">
              <a:buNone/>
              <a:defRPr sz="10900" b="1"/>
            </a:lvl3pPr>
            <a:lvl4pPr marL="8303109" indent="0">
              <a:buNone/>
              <a:defRPr sz="9700" b="1"/>
            </a:lvl4pPr>
            <a:lvl5pPr marL="11070816" indent="0">
              <a:buNone/>
              <a:defRPr sz="9700" b="1"/>
            </a:lvl5pPr>
            <a:lvl6pPr marL="13838523" indent="0">
              <a:buNone/>
              <a:defRPr sz="9700" b="1"/>
            </a:lvl6pPr>
            <a:lvl7pPr marL="16606224" indent="0">
              <a:buNone/>
              <a:defRPr sz="9700" b="1"/>
            </a:lvl7pPr>
            <a:lvl8pPr marL="19373931" indent="0">
              <a:buNone/>
              <a:defRPr sz="9700" b="1"/>
            </a:lvl8pPr>
            <a:lvl9pPr marL="22141632" indent="0">
              <a:buNone/>
              <a:defRPr sz="97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143001" y="16239067"/>
            <a:ext cx="10100470" cy="29502950"/>
          </a:xfrm>
        </p:spPr>
        <p:txBody>
          <a:bodyPr/>
          <a:lstStyle>
            <a:lvl1pPr>
              <a:defRPr sz="14500"/>
            </a:lvl1pPr>
            <a:lvl2pPr>
              <a:defRPr sz="12100"/>
            </a:lvl2pPr>
            <a:lvl3pPr>
              <a:defRPr sz="10900"/>
            </a:lvl3pPr>
            <a:lvl4pPr>
              <a:defRPr sz="9700"/>
            </a:lvl4pPr>
            <a:lvl5pPr>
              <a:defRPr sz="9700"/>
            </a:lvl5pPr>
            <a:lvl6pPr>
              <a:defRPr sz="9700"/>
            </a:lvl6pPr>
            <a:lvl7pPr>
              <a:defRPr sz="9700"/>
            </a:lvl7pPr>
            <a:lvl8pPr>
              <a:defRPr sz="9700"/>
            </a:lvl8pPr>
            <a:lvl9pPr>
              <a:defRPr sz="97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11612566" y="11462177"/>
            <a:ext cx="10104438" cy="4776890"/>
          </a:xfrm>
        </p:spPr>
        <p:txBody>
          <a:bodyPr anchor="b"/>
          <a:lstStyle>
            <a:lvl1pPr marL="0" indent="0">
              <a:buNone/>
              <a:defRPr sz="14500" b="1"/>
            </a:lvl1pPr>
            <a:lvl2pPr marL="2767701" indent="0">
              <a:buNone/>
              <a:defRPr sz="12100" b="1"/>
            </a:lvl2pPr>
            <a:lvl3pPr marL="5535408" indent="0">
              <a:buNone/>
              <a:defRPr sz="10900" b="1"/>
            </a:lvl3pPr>
            <a:lvl4pPr marL="8303109" indent="0">
              <a:buNone/>
              <a:defRPr sz="9700" b="1"/>
            </a:lvl4pPr>
            <a:lvl5pPr marL="11070816" indent="0">
              <a:buNone/>
              <a:defRPr sz="9700" b="1"/>
            </a:lvl5pPr>
            <a:lvl6pPr marL="13838523" indent="0">
              <a:buNone/>
              <a:defRPr sz="9700" b="1"/>
            </a:lvl6pPr>
            <a:lvl7pPr marL="16606224" indent="0">
              <a:buNone/>
              <a:defRPr sz="9700" b="1"/>
            </a:lvl7pPr>
            <a:lvl8pPr marL="19373931" indent="0">
              <a:buNone/>
              <a:defRPr sz="9700" b="1"/>
            </a:lvl8pPr>
            <a:lvl9pPr marL="22141632" indent="0">
              <a:buNone/>
              <a:defRPr sz="97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11612566" y="16239067"/>
            <a:ext cx="10104438" cy="29502950"/>
          </a:xfrm>
        </p:spPr>
        <p:txBody>
          <a:bodyPr/>
          <a:lstStyle>
            <a:lvl1pPr>
              <a:defRPr sz="14500"/>
            </a:lvl1pPr>
            <a:lvl2pPr>
              <a:defRPr sz="12100"/>
            </a:lvl2pPr>
            <a:lvl3pPr>
              <a:defRPr sz="10900"/>
            </a:lvl3pPr>
            <a:lvl4pPr>
              <a:defRPr sz="9700"/>
            </a:lvl4pPr>
            <a:lvl5pPr>
              <a:defRPr sz="9700"/>
            </a:lvl5pPr>
            <a:lvl6pPr>
              <a:defRPr sz="9700"/>
            </a:lvl6pPr>
            <a:lvl7pPr>
              <a:defRPr sz="9700"/>
            </a:lvl7pPr>
            <a:lvl8pPr>
              <a:defRPr sz="9700"/>
            </a:lvl8pPr>
            <a:lvl9pPr>
              <a:defRPr sz="97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19D83F-DCB4-4FB4-9496-8CDF22EF0675}" type="datetimeFigureOut">
              <a:rPr lang="en-US" smtClean="0"/>
              <a:t>7/13/201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590B27-B76F-4BE1-B4F1-F0FA2F71961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1296746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19D83F-DCB4-4FB4-9496-8CDF22EF0675}" type="datetimeFigureOut">
              <a:rPr lang="en-US" smtClean="0"/>
              <a:t>7/13/201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590B27-B76F-4BE1-B4F1-F0FA2F71961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9404761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19D83F-DCB4-4FB4-9496-8CDF22EF0675}" type="datetimeFigureOut">
              <a:rPr lang="en-US" smtClean="0"/>
              <a:t>7/13/201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590B27-B76F-4BE1-B4F1-F0FA2F71961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3680550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43004" y="2038773"/>
            <a:ext cx="7520783" cy="8676640"/>
          </a:xfrm>
        </p:spPr>
        <p:txBody>
          <a:bodyPr anchor="b"/>
          <a:lstStyle>
            <a:lvl1pPr algn="l">
              <a:defRPr sz="121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8937625" y="2038786"/>
            <a:ext cx="12779375" cy="43703244"/>
          </a:xfrm>
        </p:spPr>
        <p:txBody>
          <a:bodyPr/>
          <a:lstStyle>
            <a:lvl1pPr>
              <a:defRPr sz="19400"/>
            </a:lvl1pPr>
            <a:lvl2pPr>
              <a:defRPr sz="17000"/>
            </a:lvl2pPr>
            <a:lvl3pPr>
              <a:defRPr sz="14500"/>
            </a:lvl3pPr>
            <a:lvl4pPr>
              <a:defRPr sz="12100"/>
            </a:lvl4pPr>
            <a:lvl5pPr>
              <a:defRPr sz="12100"/>
            </a:lvl5pPr>
            <a:lvl6pPr>
              <a:defRPr sz="12100"/>
            </a:lvl6pPr>
            <a:lvl7pPr>
              <a:defRPr sz="12100"/>
            </a:lvl7pPr>
            <a:lvl8pPr>
              <a:defRPr sz="12100"/>
            </a:lvl8pPr>
            <a:lvl9pPr>
              <a:defRPr sz="121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143004" y="10715426"/>
            <a:ext cx="7520783" cy="35026604"/>
          </a:xfrm>
        </p:spPr>
        <p:txBody>
          <a:bodyPr/>
          <a:lstStyle>
            <a:lvl1pPr marL="0" indent="0">
              <a:buNone/>
              <a:defRPr sz="8500"/>
            </a:lvl1pPr>
            <a:lvl2pPr marL="2767701" indent="0">
              <a:buNone/>
              <a:defRPr sz="7300"/>
            </a:lvl2pPr>
            <a:lvl3pPr marL="5535408" indent="0">
              <a:buNone/>
              <a:defRPr sz="6100"/>
            </a:lvl3pPr>
            <a:lvl4pPr marL="8303109" indent="0">
              <a:buNone/>
              <a:defRPr sz="5500"/>
            </a:lvl4pPr>
            <a:lvl5pPr marL="11070816" indent="0">
              <a:buNone/>
              <a:defRPr sz="5500"/>
            </a:lvl5pPr>
            <a:lvl6pPr marL="13838523" indent="0">
              <a:buNone/>
              <a:defRPr sz="5500"/>
            </a:lvl6pPr>
            <a:lvl7pPr marL="16606224" indent="0">
              <a:buNone/>
              <a:defRPr sz="5500"/>
            </a:lvl7pPr>
            <a:lvl8pPr marL="19373931" indent="0">
              <a:buNone/>
              <a:defRPr sz="5500"/>
            </a:lvl8pPr>
            <a:lvl9pPr marL="22141632" indent="0">
              <a:buNone/>
              <a:defRPr sz="55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19D83F-DCB4-4FB4-9496-8CDF22EF0675}" type="datetimeFigureOut">
              <a:rPr lang="en-US" smtClean="0"/>
              <a:t>7/13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590B27-B76F-4BE1-B4F1-F0FA2F71961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8657713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480720" y="35844480"/>
            <a:ext cx="13716000" cy="4231644"/>
          </a:xfrm>
        </p:spPr>
        <p:txBody>
          <a:bodyPr anchor="b"/>
          <a:lstStyle>
            <a:lvl1pPr algn="l">
              <a:defRPr sz="121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4480720" y="4575387"/>
            <a:ext cx="13716000" cy="30723840"/>
          </a:xfrm>
        </p:spPr>
        <p:txBody>
          <a:bodyPr/>
          <a:lstStyle>
            <a:lvl1pPr marL="0" indent="0">
              <a:buNone/>
              <a:defRPr sz="19400"/>
            </a:lvl1pPr>
            <a:lvl2pPr marL="2767701" indent="0">
              <a:buNone/>
              <a:defRPr sz="17000"/>
            </a:lvl2pPr>
            <a:lvl3pPr marL="5535408" indent="0">
              <a:buNone/>
              <a:defRPr sz="14500"/>
            </a:lvl3pPr>
            <a:lvl4pPr marL="8303109" indent="0">
              <a:buNone/>
              <a:defRPr sz="12100"/>
            </a:lvl4pPr>
            <a:lvl5pPr marL="11070816" indent="0">
              <a:buNone/>
              <a:defRPr sz="12100"/>
            </a:lvl5pPr>
            <a:lvl6pPr marL="13838523" indent="0">
              <a:buNone/>
              <a:defRPr sz="12100"/>
            </a:lvl6pPr>
            <a:lvl7pPr marL="16606224" indent="0">
              <a:buNone/>
              <a:defRPr sz="12100"/>
            </a:lvl7pPr>
            <a:lvl8pPr marL="19373931" indent="0">
              <a:buNone/>
              <a:defRPr sz="12100"/>
            </a:lvl8pPr>
            <a:lvl9pPr marL="22141632" indent="0">
              <a:buNone/>
              <a:defRPr sz="121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480720" y="40076124"/>
            <a:ext cx="13716000" cy="6009636"/>
          </a:xfrm>
        </p:spPr>
        <p:txBody>
          <a:bodyPr/>
          <a:lstStyle>
            <a:lvl1pPr marL="0" indent="0">
              <a:buNone/>
              <a:defRPr sz="8500"/>
            </a:lvl1pPr>
            <a:lvl2pPr marL="2767701" indent="0">
              <a:buNone/>
              <a:defRPr sz="7300"/>
            </a:lvl2pPr>
            <a:lvl3pPr marL="5535408" indent="0">
              <a:buNone/>
              <a:defRPr sz="6100"/>
            </a:lvl3pPr>
            <a:lvl4pPr marL="8303109" indent="0">
              <a:buNone/>
              <a:defRPr sz="5500"/>
            </a:lvl4pPr>
            <a:lvl5pPr marL="11070816" indent="0">
              <a:buNone/>
              <a:defRPr sz="5500"/>
            </a:lvl5pPr>
            <a:lvl6pPr marL="13838523" indent="0">
              <a:buNone/>
              <a:defRPr sz="5500"/>
            </a:lvl6pPr>
            <a:lvl7pPr marL="16606224" indent="0">
              <a:buNone/>
              <a:defRPr sz="5500"/>
            </a:lvl7pPr>
            <a:lvl8pPr marL="19373931" indent="0">
              <a:buNone/>
              <a:defRPr sz="5500"/>
            </a:lvl8pPr>
            <a:lvl9pPr marL="22141632" indent="0">
              <a:buNone/>
              <a:defRPr sz="55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19D83F-DCB4-4FB4-9496-8CDF22EF0675}" type="datetimeFigureOut">
              <a:rPr lang="en-US" smtClean="0"/>
              <a:t>7/13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590B27-B76F-4BE1-B4F1-F0FA2F71961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7121376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143000" y="2050630"/>
            <a:ext cx="20574000" cy="8534400"/>
          </a:xfrm>
          <a:prstGeom prst="rect">
            <a:avLst/>
          </a:prstGeom>
        </p:spPr>
        <p:txBody>
          <a:bodyPr vert="horz" lIns="553540" tIns="276773" rIns="553540" bIns="276773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143000" y="11948172"/>
            <a:ext cx="20574000" cy="33793857"/>
          </a:xfrm>
          <a:prstGeom prst="rect">
            <a:avLst/>
          </a:prstGeom>
        </p:spPr>
        <p:txBody>
          <a:bodyPr vert="horz" lIns="553540" tIns="276773" rIns="553540" bIns="276773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1143000" y="47460761"/>
            <a:ext cx="5334000" cy="2726267"/>
          </a:xfrm>
          <a:prstGeom prst="rect">
            <a:avLst/>
          </a:prstGeom>
        </p:spPr>
        <p:txBody>
          <a:bodyPr vert="horz" lIns="553540" tIns="276773" rIns="553540" bIns="276773" rtlCol="0" anchor="ctr"/>
          <a:lstStyle>
            <a:lvl1pPr algn="l">
              <a:defRPr sz="73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819D83F-DCB4-4FB4-9496-8CDF22EF0675}" type="datetimeFigureOut">
              <a:rPr lang="en-US" smtClean="0"/>
              <a:t>7/13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7810500" y="47460761"/>
            <a:ext cx="7239000" cy="2726267"/>
          </a:xfrm>
          <a:prstGeom prst="rect">
            <a:avLst/>
          </a:prstGeom>
        </p:spPr>
        <p:txBody>
          <a:bodyPr vert="horz" lIns="553540" tIns="276773" rIns="553540" bIns="276773" rtlCol="0" anchor="ctr"/>
          <a:lstStyle>
            <a:lvl1pPr algn="ctr">
              <a:defRPr sz="73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6383000" y="47460761"/>
            <a:ext cx="5334000" cy="2726267"/>
          </a:xfrm>
          <a:prstGeom prst="rect">
            <a:avLst/>
          </a:prstGeom>
        </p:spPr>
        <p:txBody>
          <a:bodyPr vert="horz" lIns="553540" tIns="276773" rIns="553540" bIns="276773" rtlCol="0" anchor="ctr"/>
          <a:lstStyle>
            <a:lvl1pPr algn="r">
              <a:defRPr sz="73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A590B27-B76F-4BE1-B4F1-F0FA2F71961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9019712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5535408" rtl="0" eaLnBrk="1" latinLnBrk="0" hangingPunct="1">
        <a:spcBef>
          <a:spcPct val="0"/>
        </a:spcBef>
        <a:buNone/>
        <a:defRPr sz="267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075780" indent="-2075780" algn="l" defTabSz="5535408" rtl="0" eaLnBrk="1" latinLnBrk="0" hangingPunct="1">
        <a:spcBef>
          <a:spcPct val="20000"/>
        </a:spcBef>
        <a:buFont typeface="Arial" pitchFamily="34" charset="0"/>
        <a:buChar char="•"/>
        <a:defRPr sz="19400" kern="1200">
          <a:solidFill>
            <a:schemeClr val="tx1"/>
          </a:solidFill>
          <a:latin typeface="+mn-lt"/>
          <a:ea typeface="+mn-ea"/>
          <a:cs typeface="+mn-cs"/>
        </a:defRPr>
      </a:lvl1pPr>
      <a:lvl2pPr marL="4497518" indent="-1729817" algn="l" defTabSz="5535408" rtl="0" eaLnBrk="1" latinLnBrk="0" hangingPunct="1">
        <a:spcBef>
          <a:spcPct val="20000"/>
        </a:spcBef>
        <a:buFont typeface="Arial" pitchFamily="34" charset="0"/>
        <a:buChar char="–"/>
        <a:defRPr sz="17000" kern="1200">
          <a:solidFill>
            <a:schemeClr val="tx1"/>
          </a:solidFill>
          <a:latin typeface="+mn-lt"/>
          <a:ea typeface="+mn-ea"/>
          <a:cs typeface="+mn-cs"/>
        </a:defRPr>
      </a:lvl2pPr>
      <a:lvl3pPr marL="6919262" indent="-1383854" algn="l" defTabSz="5535408" rtl="0" eaLnBrk="1" latinLnBrk="0" hangingPunct="1">
        <a:spcBef>
          <a:spcPct val="20000"/>
        </a:spcBef>
        <a:buFont typeface="Arial" pitchFamily="34" charset="0"/>
        <a:buChar char="•"/>
        <a:defRPr sz="14500" kern="1200">
          <a:solidFill>
            <a:schemeClr val="tx1"/>
          </a:solidFill>
          <a:latin typeface="+mn-lt"/>
          <a:ea typeface="+mn-ea"/>
          <a:cs typeface="+mn-cs"/>
        </a:defRPr>
      </a:lvl3pPr>
      <a:lvl4pPr marL="9686963" indent="-1383854" algn="l" defTabSz="5535408" rtl="0" eaLnBrk="1" latinLnBrk="0" hangingPunct="1">
        <a:spcBef>
          <a:spcPct val="20000"/>
        </a:spcBef>
        <a:buFont typeface="Arial" pitchFamily="34" charset="0"/>
        <a:buChar char="–"/>
        <a:defRPr sz="12100" kern="1200">
          <a:solidFill>
            <a:schemeClr val="tx1"/>
          </a:solidFill>
          <a:latin typeface="+mn-lt"/>
          <a:ea typeface="+mn-ea"/>
          <a:cs typeface="+mn-cs"/>
        </a:defRPr>
      </a:lvl4pPr>
      <a:lvl5pPr marL="12454670" indent="-1383854" algn="l" defTabSz="5535408" rtl="0" eaLnBrk="1" latinLnBrk="0" hangingPunct="1">
        <a:spcBef>
          <a:spcPct val="20000"/>
        </a:spcBef>
        <a:buFont typeface="Arial" pitchFamily="34" charset="0"/>
        <a:buChar char="»"/>
        <a:defRPr sz="12100" kern="1200">
          <a:solidFill>
            <a:schemeClr val="tx1"/>
          </a:solidFill>
          <a:latin typeface="+mn-lt"/>
          <a:ea typeface="+mn-ea"/>
          <a:cs typeface="+mn-cs"/>
        </a:defRPr>
      </a:lvl5pPr>
      <a:lvl6pPr marL="15222371" indent="-1383854" algn="l" defTabSz="5535408" rtl="0" eaLnBrk="1" latinLnBrk="0" hangingPunct="1">
        <a:spcBef>
          <a:spcPct val="20000"/>
        </a:spcBef>
        <a:buFont typeface="Arial" pitchFamily="34" charset="0"/>
        <a:buChar char="•"/>
        <a:defRPr sz="12100" kern="1200">
          <a:solidFill>
            <a:schemeClr val="tx1"/>
          </a:solidFill>
          <a:latin typeface="+mn-lt"/>
          <a:ea typeface="+mn-ea"/>
          <a:cs typeface="+mn-cs"/>
        </a:defRPr>
      </a:lvl6pPr>
      <a:lvl7pPr marL="17990078" indent="-1383854" algn="l" defTabSz="5535408" rtl="0" eaLnBrk="1" latinLnBrk="0" hangingPunct="1">
        <a:spcBef>
          <a:spcPct val="20000"/>
        </a:spcBef>
        <a:buFont typeface="Arial" pitchFamily="34" charset="0"/>
        <a:buChar char="•"/>
        <a:defRPr sz="12100" kern="1200">
          <a:solidFill>
            <a:schemeClr val="tx1"/>
          </a:solidFill>
          <a:latin typeface="+mn-lt"/>
          <a:ea typeface="+mn-ea"/>
          <a:cs typeface="+mn-cs"/>
        </a:defRPr>
      </a:lvl7pPr>
      <a:lvl8pPr marL="20757779" indent="-1383854" algn="l" defTabSz="5535408" rtl="0" eaLnBrk="1" latinLnBrk="0" hangingPunct="1">
        <a:spcBef>
          <a:spcPct val="20000"/>
        </a:spcBef>
        <a:buFont typeface="Arial" pitchFamily="34" charset="0"/>
        <a:buChar char="•"/>
        <a:defRPr sz="12100" kern="1200">
          <a:solidFill>
            <a:schemeClr val="tx1"/>
          </a:solidFill>
          <a:latin typeface="+mn-lt"/>
          <a:ea typeface="+mn-ea"/>
          <a:cs typeface="+mn-cs"/>
        </a:defRPr>
      </a:lvl8pPr>
      <a:lvl9pPr marL="23525486" indent="-1383854" algn="l" defTabSz="5535408" rtl="0" eaLnBrk="1" latinLnBrk="0" hangingPunct="1">
        <a:spcBef>
          <a:spcPct val="20000"/>
        </a:spcBef>
        <a:buFont typeface="Arial" pitchFamily="34" charset="0"/>
        <a:buChar char="•"/>
        <a:defRPr sz="121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5535408" rtl="0" eaLnBrk="1" latinLnBrk="0" hangingPunct="1">
        <a:defRPr sz="10900" kern="1200">
          <a:solidFill>
            <a:schemeClr val="tx1"/>
          </a:solidFill>
          <a:latin typeface="+mn-lt"/>
          <a:ea typeface="+mn-ea"/>
          <a:cs typeface="+mn-cs"/>
        </a:defRPr>
      </a:lvl1pPr>
      <a:lvl2pPr marL="2767701" algn="l" defTabSz="5535408" rtl="0" eaLnBrk="1" latinLnBrk="0" hangingPunct="1">
        <a:defRPr sz="10900" kern="1200">
          <a:solidFill>
            <a:schemeClr val="tx1"/>
          </a:solidFill>
          <a:latin typeface="+mn-lt"/>
          <a:ea typeface="+mn-ea"/>
          <a:cs typeface="+mn-cs"/>
        </a:defRPr>
      </a:lvl2pPr>
      <a:lvl3pPr marL="5535408" algn="l" defTabSz="5535408" rtl="0" eaLnBrk="1" latinLnBrk="0" hangingPunct="1">
        <a:defRPr sz="10900" kern="1200">
          <a:solidFill>
            <a:schemeClr val="tx1"/>
          </a:solidFill>
          <a:latin typeface="+mn-lt"/>
          <a:ea typeface="+mn-ea"/>
          <a:cs typeface="+mn-cs"/>
        </a:defRPr>
      </a:lvl3pPr>
      <a:lvl4pPr marL="8303109" algn="l" defTabSz="5535408" rtl="0" eaLnBrk="1" latinLnBrk="0" hangingPunct="1">
        <a:defRPr sz="10900" kern="1200">
          <a:solidFill>
            <a:schemeClr val="tx1"/>
          </a:solidFill>
          <a:latin typeface="+mn-lt"/>
          <a:ea typeface="+mn-ea"/>
          <a:cs typeface="+mn-cs"/>
        </a:defRPr>
      </a:lvl4pPr>
      <a:lvl5pPr marL="11070816" algn="l" defTabSz="5535408" rtl="0" eaLnBrk="1" latinLnBrk="0" hangingPunct="1">
        <a:defRPr sz="10900" kern="1200">
          <a:solidFill>
            <a:schemeClr val="tx1"/>
          </a:solidFill>
          <a:latin typeface="+mn-lt"/>
          <a:ea typeface="+mn-ea"/>
          <a:cs typeface="+mn-cs"/>
        </a:defRPr>
      </a:lvl5pPr>
      <a:lvl6pPr marL="13838523" algn="l" defTabSz="5535408" rtl="0" eaLnBrk="1" latinLnBrk="0" hangingPunct="1">
        <a:defRPr sz="10900" kern="1200">
          <a:solidFill>
            <a:schemeClr val="tx1"/>
          </a:solidFill>
          <a:latin typeface="+mn-lt"/>
          <a:ea typeface="+mn-ea"/>
          <a:cs typeface="+mn-cs"/>
        </a:defRPr>
      </a:lvl6pPr>
      <a:lvl7pPr marL="16606224" algn="l" defTabSz="5535408" rtl="0" eaLnBrk="1" latinLnBrk="0" hangingPunct="1">
        <a:defRPr sz="10900" kern="1200">
          <a:solidFill>
            <a:schemeClr val="tx1"/>
          </a:solidFill>
          <a:latin typeface="+mn-lt"/>
          <a:ea typeface="+mn-ea"/>
          <a:cs typeface="+mn-cs"/>
        </a:defRPr>
      </a:lvl7pPr>
      <a:lvl8pPr marL="19373931" algn="l" defTabSz="5535408" rtl="0" eaLnBrk="1" latinLnBrk="0" hangingPunct="1">
        <a:defRPr sz="10900" kern="1200">
          <a:solidFill>
            <a:schemeClr val="tx1"/>
          </a:solidFill>
          <a:latin typeface="+mn-lt"/>
          <a:ea typeface="+mn-ea"/>
          <a:cs typeface="+mn-cs"/>
        </a:defRPr>
      </a:lvl8pPr>
      <a:lvl9pPr marL="22141632" algn="l" defTabSz="5535408" rtl="0" eaLnBrk="1" latinLnBrk="0" hangingPunct="1">
        <a:defRPr sz="109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Table 5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387332334"/>
              </p:ext>
            </p:extLst>
          </p:nvPr>
        </p:nvGraphicFramePr>
        <p:xfrm>
          <a:off x="2286000" y="304800"/>
          <a:ext cx="7619999" cy="50652654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103633"/>
                <a:gridCol w="1098432"/>
                <a:gridCol w="1095705"/>
                <a:gridCol w="832493"/>
                <a:gridCol w="639047"/>
                <a:gridCol w="940631"/>
                <a:gridCol w="934099"/>
                <a:gridCol w="975959"/>
              </a:tblGrid>
              <a:tr h="502730"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</a:rPr>
                        <a:t>Haplotypes </a:t>
                      </a:r>
                      <a:endParaRPr lang="en-US" sz="1400" dirty="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</a:rPr>
                        <a:t>Populations</a:t>
                      </a:r>
                      <a:endParaRPr lang="en-US" sz="1400" dirty="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East African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African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Asian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European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American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Australian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</a:tr>
              <a:tr h="244925"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1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63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26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16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34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14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12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</a:tr>
              <a:tr h="244925"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2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Niloti3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</a:tr>
              <a:tr h="244925"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Beja12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.0116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</a:tr>
              <a:tr h="244925"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3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Niloti4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.00581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</a:tr>
              <a:tr h="244925"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4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Niloti5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</a:tr>
              <a:tr h="244925"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Beja11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</a:tr>
              <a:tr h="244925"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Nuba16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.0174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</a:tr>
              <a:tr h="244925"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5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Niloti6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.00581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</a:tr>
              <a:tr h="244925"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6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Nilot13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</a:tr>
              <a:tr h="244925"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Nilot21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.0116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</a:tr>
              <a:tr h="244925"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7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Nilot14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</a:tr>
              <a:tr h="433485"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Austra15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.00581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.0556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</a:tr>
              <a:tr h="244925"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8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Nilot17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</a:tr>
              <a:tr h="244925"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Baga96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</a:rPr>
                        <a:t> </a:t>
                      </a:r>
                      <a:endParaRPr lang="en-US" sz="1400" dirty="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</a:tr>
              <a:tr h="244925"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Baga57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</a:tr>
              <a:tr h="244925"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Baga60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</a:tr>
              <a:tr h="244925"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Alch72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</a:tr>
              <a:tr h="244925"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Alch08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</a:tr>
              <a:tr h="244925"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EriN14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</a:tr>
              <a:tr h="244925"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EriN17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</a:tr>
              <a:tr h="244925"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EriH33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</a:tr>
              <a:tr h="244925"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ErTig55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</a:tr>
              <a:tr h="244925"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ErAf67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</a:tr>
              <a:tr h="244925"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ErB85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</a:tr>
              <a:tr h="244925"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ErB87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.0756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</a:tr>
              <a:tr h="244925"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9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Nilot18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.00581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</a:tr>
              <a:tr h="244925"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10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Nilot19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.00581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</a:tr>
              <a:tr h="244925"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11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Nilot20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.00581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</a:tr>
              <a:tr h="244925"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12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Beja4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</a:tr>
              <a:tr h="502730"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NUBIAN5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</a:tr>
              <a:tr h="502730"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NUBIAN26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</a:tr>
              <a:tr h="244925"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Lugb82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</a:tr>
              <a:tr h="244925"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Lugb87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</a:tr>
              <a:tr h="244925"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Lug678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</a:tr>
              <a:tr h="244925"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Lugb80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</a:tr>
              <a:tr h="244925"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Alch34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</a:tr>
              <a:tr h="244925"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EriN12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</a:tr>
              <a:tr h="244925"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EriN13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</a:tr>
              <a:tr h="244925"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EriN18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</a:tr>
              <a:tr h="244925"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EriK29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</a:tr>
              <a:tr h="244925"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EriH31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</a:tr>
              <a:tr h="244925"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ErTig54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</a:tr>
              <a:tr h="244925"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ErAf65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</a:tr>
              <a:tr h="244925"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ErAf70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</a:tr>
              <a:tr h="244925"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ErSh80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</a:tr>
              <a:tr h="244925"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South2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</a:tr>
              <a:tr h="502730"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South3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.0988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.0377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</a:tr>
              <a:tr h="244925"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13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Beja8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</a:tr>
              <a:tr h="244925"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Nuba12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</a:tr>
              <a:tr h="244925"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Nuba13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.0174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</a:tr>
              <a:tr h="244925"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14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Beja13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.00581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</a:tr>
              <a:tr h="244925"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15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Beja18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.00581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</a:tr>
              <a:tr h="244925"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16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Beja22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.00581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</a:tr>
              <a:tr h="244925"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17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Beja23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.00581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</a:tr>
              <a:tr h="244925"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18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Beja24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.00581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</a:tr>
              <a:tr h="244925"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19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Nubian4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</a:tr>
              <a:tr h="502730"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Nubian27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.0116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</a:tr>
              <a:tr h="502730"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20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Nubian10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.00581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</a:tr>
              <a:tr h="502730"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21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Nubian19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.00581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</a:tr>
              <a:tr h="502730"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22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Nubian22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.00581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</a:tr>
              <a:tr h="244925"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23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Nuba1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</a:tr>
              <a:tr h="502730"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Southam8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.00581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.05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</a:tr>
              <a:tr h="244925"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24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Nuba4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.00581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</a:tr>
              <a:tr h="244925"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25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Nuba5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.00581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</a:tr>
              <a:tr h="244925"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26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Nuba7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.00581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</a:tr>
              <a:tr h="244925"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27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Nuba8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.00581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</a:tr>
              <a:tr h="244925"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28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Nuba15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.00581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</a:tr>
              <a:tr h="244925"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29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Nuba17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.00581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</a:tr>
              <a:tr h="244925"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30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Nuba18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.00581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</a:tr>
              <a:tr h="244925"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31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Baga43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</a:tr>
              <a:tr h="244925"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Baga89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</a:tr>
              <a:tr h="244925"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Alch68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</a:tr>
              <a:tr h="502730"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Morocc6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.0174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.0189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</a:tr>
              <a:tr h="244925"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32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Lugb86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.00581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</a:tr>
              <a:tr h="244925"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33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Lugb74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.00581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</a:tr>
              <a:tr h="244925"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34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Lugb75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.00581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</a:tr>
              <a:tr h="244925"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35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Lugb76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.00581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</a:tr>
              <a:tr h="244925"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36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Lugb79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</a:tr>
              <a:tr h="502730"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SAN4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.00581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.0189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</a:tr>
              <a:tr h="244925"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37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Lugb96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</a:tr>
              <a:tr h="244925"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Alch09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</a:tr>
              <a:tr h="244925"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EriK26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</a:tr>
              <a:tr h="244925"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ERTg45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.0233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</a:tr>
              <a:tr h="244925"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38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Lugb00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</a:tr>
              <a:tr h="502730"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SAN3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.00581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.0189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</a:tr>
              <a:tr h="244925"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39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Alch73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</a:tr>
              <a:tr h="244925"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EriH35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</a:tr>
              <a:tr h="244925"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ErTg41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</a:tr>
              <a:tr h="244925"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ErTg42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</a:tr>
              <a:tr h="244925"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ErTg47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.0291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</a:tr>
              <a:tr h="244925"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40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Alch38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.00581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</a:tr>
              <a:tr h="244925"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41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Ethiop2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</a:tr>
              <a:tr h="433485"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Ethiop14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</a:tr>
              <a:tr h="244925"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ErTig51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</a:tr>
              <a:tr h="433485"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Morocc7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</a:tr>
              <a:tr h="433485"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Morocc8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</a:tr>
              <a:tr h="502730"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Morocc15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</a:tr>
              <a:tr h="502730"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Morocc16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</a:tr>
              <a:tr h="502730"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Morocc17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</a:tr>
              <a:tr h="502730"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Morocc18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</a:tr>
              <a:tr h="502730"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Morocc19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</a:tr>
              <a:tr h="244925"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Nigeri1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</a:tr>
              <a:tr h="244925"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Nigeri2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</a:tr>
              <a:tr h="244925"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Tunisi1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</a:tr>
              <a:tr h="244925"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Tunisi2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</a:tr>
              <a:tr h="244925"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Iraq2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</a:tr>
              <a:tr h="244925"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Spain2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</a:tr>
              <a:tr h="244925"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Austral6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</a:tr>
              <a:tr h="433485"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Austral7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.0174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.208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.05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.0222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.111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</a:tr>
              <a:tr h="244925"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41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EriN11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.00581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</a:tr>
              <a:tr h="244925"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43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EriN15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.00581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</a:tr>
              <a:tr h="244925"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44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EriN16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</a:tr>
              <a:tr h="244925"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EriK21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</a:tr>
              <a:tr h="244925"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EriK27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</a:tr>
              <a:tr h="244925"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EriK28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</a:tr>
              <a:tr h="502730"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America1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</a:tr>
              <a:tr h="502730"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Southam9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.0233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</a:tr>
              <a:tr h="244925"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45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EriH30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.00581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</a:tr>
              <a:tr h="244925"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46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EriH32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</a:tr>
              <a:tr h="244925"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EriH37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</a:tr>
              <a:tr h="244925"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ErTg44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</a:tr>
              <a:tr h="244925"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ErTig50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</a:tr>
              <a:tr h="244925"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ErSh76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.0291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</a:tr>
              <a:tr h="244925"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47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EriH34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</a:tr>
              <a:tr h="433485"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Chinese3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</a:tr>
              <a:tr h="244925"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Japan2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.00581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.1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</a:tr>
              <a:tr h="244925"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48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ErTg39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</a:tr>
              <a:tr h="244925"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ErTig57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</a:tr>
              <a:tr h="244925"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Austral4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.0116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.0556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</a:tr>
              <a:tr h="244925"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49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ERTg40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.00581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</a:tr>
              <a:tr h="244925"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50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ErTg48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.00581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</a:tr>
              <a:tr h="244925"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51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ErTig49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.00581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</a:tr>
              <a:tr h="244925"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52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ErTig52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.00581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</a:tr>
              <a:tr h="244925"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53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ErTig53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</a:tr>
              <a:tr h="244925"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ErB84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</a:tr>
              <a:tr h="244925"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Italy3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.0116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.0222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</a:tr>
              <a:tr h="244925"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54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ErB86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.00581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</a:tr>
              <a:tr h="433485"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55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Mkamba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.00581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</a:tr>
              <a:tr h="433485"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56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Morocc9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</a:tr>
              <a:tr h="502730"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Morocc23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</a:tr>
              <a:tr h="502730"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Morocc24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</a:tr>
              <a:tr h="244925"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Spain6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</a:tr>
              <a:tr h="244925"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Spain7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</a:tr>
              <a:tr h="244925"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Spain8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</a:tr>
              <a:tr h="244925"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Spain9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</a:tr>
              <a:tr h="502730"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Spain10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.05606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.111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</a:tr>
              <a:tr h="244925"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57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South1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</a:tr>
              <a:tr h="502730"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Armenia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.0189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.0222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</a:tr>
              <a:tr h="502730"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58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South4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.0189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</a:tr>
              <a:tr h="502730"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59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SAN1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.0189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</a:tr>
              <a:tr h="244925"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60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SAN5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</a:tr>
              <a:tr h="244925"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Pygmy1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</a:tr>
              <a:tr h="502730"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Pygmy4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.0566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</a:tr>
              <a:tr h="244925"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61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Pygmy2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</a:tr>
              <a:tr h="502730"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Pygmy3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.0377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</a:tr>
              <a:tr h="433485"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62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Saudi2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.05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</a:tr>
              <a:tr h="244925"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63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Finland2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.0222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</a:tr>
              <a:tr h="244925"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64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France2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.0222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</a:tr>
              <a:tr h="244925"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65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Spain13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.0222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</a:tr>
              <a:tr h="502730"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66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America8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</a:tr>
              <a:tr h="502730"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America9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</a:tr>
              <a:tr h="502730"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Southam6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.15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</a:tr>
              <a:tr h="244925"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67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Austral3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.0556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</a:tr>
              <a:tr h="433485"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68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Austra14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.0556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</a:tr>
              <a:tr h="244925"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Total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172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53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20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45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20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>
                  <a:txBody>
                    <a:bodyPr/>
                    <a:lstStyle/>
                    <a:p>
                      <a:pPr marL="182880" algn="r">
                        <a:lnSpc>
                          <a:spcPct val="115000"/>
                        </a:lnSpc>
                        <a:spcBef>
                          <a:spcPts val="14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18</a:t>
                      </a:r>
                      <a:endParaRPr lang="en-US" sz="140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</a:tr>
              <a:tr h="319468">
                <a:tc gridSpan="8">
                  <a:txBody>
                    <a:bodyPr/>
                    <a:lstStyle/>
                    <a:p>
                      <a:pPr marL="182880" algn="just">
                        <a:lnSpc>
                          <a:spcPct val="150000"/>
                        </a:lnSpc>
                        <a:spcBef>
                          <a:spcPts val="140"/>
                        </a:spcBef>
                        <a:spcAft>
                          <a:spcPts val="140"/>
                        </a:spcAft>
                      </a:pPr>
                      <a:r>
                        <a:rPr lang="en-US" sz="1400" dirty="0">
                          <a:effectLst/>
                        </a:rPr>
                        <a:t>Note: Haplotype 1 includes 164 individuals from all populations</a:t>
                      </a:r>
                      <a:endParaRPr lang="en-US" sz="1400" dirty="0">
                        <a:solidFill>
                          <a:srgbClr val="00000A"/>
                        </a:solidFill>
                        <a:effectLst/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8933" marR="9843" marT="0" marB="0" anchor="b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8149017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996</TotalTime>
  <Words>663</Words>
  <Application>Microsoft Office PowerPoint</Application>
  <PresentationFormat>Custom</PresentationFormat>
  <Paragraphs>1329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Toshiba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Eyoab</dc:creator>
  <cp:lastModifiedBy>Eyoab</cp:lastModifiedBy>
  <cp:revision>3</cp:revision>
  <dcterms:created xsi:type="dcterms:W3CDTF">2013-07-13T15:32:05Z</dcterms:created>
  <dcterms:modified xsi:type="dcterms:W3CDTF">2013-07-15T17:28:49Z</dcterms:modified>
</cp:coreProperties>
</file>